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07"/>
    <p:restoredTop sz="94643"/>
  </p:normalViewPr>
  <p:slideViewPr>
    <p:cSldViewPr snapToGrid="0" snapToObjects="1">
      <p:cViewPr varScale="1">
        <p:scale>
          <a:sx n="119" d="100"/>
          <a:sy n="119" d="100"/>
        </p:scale>
        <p:origin x="46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2219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785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502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2732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6842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956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2933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6715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624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1268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493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6C8B1-ED2D-514A-86DA-9F9B779606E0}" type="datetimeFigureOut">
              <a:rPr lang="de-DE" smtClean="0"/>
              <a:t>24.02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BCCDA-ABF9-E640-BC2D-BFC10C8636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0490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eck 9"/>
          <p:cNvSpPr/>
          <p:nvPr/>
        </p:nvSpPr>
        <p:spPr>
          <a:xfrm>
            <a:off x="2486526" y="4365671"/>
            <a:ext cx="7006465" cy="592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T PCR of HPV E6 and E7 in HNSCC cell lines. HPV E6 and E7 was detected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D-SCC-2, 93VU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154 </a:t>
            </a:r>
            <a:r>
              <a:rPr lang="en-US" sz="14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lines but not in all other used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sz="140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s. As control a positive patient probe was used.</a:t>
            </a:r>
            <a:endParaRPr lang="de-DE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uppieren 10">
            <a:extLst>
              <a:ext uri="{FF2B5EF4-FFF2-40B4-BE49-F238E27FC236}">
                <a16:creationId xmlns="" xmlns:a16="http://schemas.microsoft.com/office/drawing/2014/main" id="{8835656E-44E5-6442-8D43-FC215F29DEBB}"/>
              </a:ext>
            </a:extLst>
          </p:cNvPr>
          <p:cNvGrpSpPr/>
          <p:nvPr/>
        </p:nvGrpSpPr>
        <p:grpSpPr>
          <a:xfrm>
            <a:off x="2684854" y="2595365"/>
            <a:ext cx="6822293" cy="1667270"/>
            <a:chOff x="2327946" y="1252073"/>
            <a:chExt cx="6822293" cy="1667270"/>
          </a:xfrm>
        </p:grpSpPr>
        <p:pic>
          <p:nvPicPr>
            <p:cNvPr id="12" name="Grafik 11">
              <a:extLst>
                <a:ext uri="{FF2B5EF4-FFF2-40B4-BE49-F238E27FC236}">
                  <a16:creationId xmlns="" xmlns:a16="http://schemas.microsoft.com/office/drawing/2014/main" id="{46A16F74-D77E-4345-8376-D3399A3CEC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37" t="4588" r="23769" b="72329"/>
            <a:stretch/>
          </p:blipFill>
          <p:spPr>
            <a:xfrm>
              <a:off x="3097184" y="1475214"/>
              <a:ext cx="5093061" cy="698338"/>
            </a:xfrm>
            <a:prstGeom prst="rect">
              <a:avLst/>
            </a:prstGeom>
          </p:spPr>
        </p:pic>
        <p:pic>
          <p:nvPicPr>
            <p:cNvPr id="13" name="Grafik 12">
              <a:extLst>
                <a:ext uri="{FF2B5EF4-FFF2-40B4-BE49-F238E27FC236}">
                  <a16:creationId xmlns="" xmlns:a16="http://schemas.microsoft.com/office/drawing/2014/main" id="{313E5DE4-FBAD-3E43-9602-958FE5F953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5" t="58495" r="25172" b="16989"/>
            <a:stretch/>
          </p:blipFill>
          <p:spPr>
            <a:xfrm>
              <a:off x="3097183" y="2221006"/>
              <a:ext cx="5093061" cy="698337"/>
            </a:xfrm>
            <a:prstGeom prst="rect">
              <a:avLst/>
            </a:prstGeom>
          </p:spPr>
        </p:pic>
        <p:sp>
          <p:nvSpPr>
            <p:cNvPr id="14" name="Textfeld 13">
              <a:extLst>
                <a:ext uri="{FF2B5EF4-FFF2-40B4-BE49-F238E27FC236}">
                  <a16:creationId xmlns="" xmlns:a16="http://schemas.microsoft.com/office/drawing/2014/main" id="{B4B836B4-81EE-4741-A911-D38EFC6D26EE}"/>
                </a:ext>
              </a:extLst>
            </p:cNvPr>
            <p:cNvSpPr txBox="1"/>
            <p:nvPr/>
          </p:nvSpPr>
          <p:spPr>
            <a:xfrm>
              <a:off x="3146347" y="1252073"/>
              <a:ext cx="5157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D2   93VU  UP154    M      Cal27     HN     SAS      UD3      UD4       UD5      UD6      UD7      M    pos. </a:t>
              </a:r>
              <a:r>
                <a:rPr lang="de-DE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="" xmlns:a16="http://schemas.microsoft.com/office/drawing/2014/main" id="{6E386F9E-66E8-4142-856E-437D42CBB045}"/>
                </a:ext>
              </a:extLst>
            </p:cNvPr>
            <p:cNvSpPr txBox="1"/>
            <p:nvPr/>
          </p:nvSpPr>
          <p:spPr>
            <a:xfrm>
              <a:off x="8370858" y="1701273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/>
                  <a:cs typeface="Arial"/>
                </a:rPr>
                <a:t>HPV16 E6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="" xmlns:a16="http://schemas.microsoft.com/office/drawing/2014/main" id="{EC2E36E7-D58D-E74F-BE23-C47A5B58C992}"/>
                </a:ext>
              </a:extLst>
            </p:cNvPr>
            <p:cNvSpPr txBox="1"/>
            <p:nvPr/>
          </p:nvSpPr>
          <p:spPr>
            <a:xfrm>
              <a:off x="8370858" y="2447064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/>
                  <a:cs typeface="Arial"/>
                </a:rPr>
                <a:t>HPV16 E7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="" xmlns:a16="http://schemas.microsoft.com/office/drawing/2014/main" id="{7F3488C3-7FB2-DC4E-95DE-4430043EB231}"/>
                </a:ext>
              </a:extLst>
            </p:cNvPr>
            <p:cNvSpPr txBox="1"/>
            <p:nvPr/>
          </p:nvSpPr>
          <p:spPr>
            <a:xfrm>
              <a:off x="2327946" y="1701273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/>
                  <a:cs typeface="Arial"/>
                </a:rPr>
                <a:t>89 </a:t>
              </a:r>
              <a:r>
                <a:rPr lang="de-DE" sz="1000" b="1" dirty="0" err="1">
                  <a:latin typeface="Arial"/>
                  <a:cs typeface="Arial"/>
                </a:rPr>
                <a:t>bp</a:t>
              </a:r>
              <a:endParaRPr lang="de-DE" sz="1000" b="1" dirty="0">
                <a:latin typeface="Arial"/>
                <a:cs typeface="Arial"/>
              </a:endParaRPr>
            </a:p>
          </p:txBody>
        </p:sp>
        <p:sp>
          <p:nvSpPr>
            <p:cNvPr id="18" name="Textfeld 17">
              <a:extLst>
                <a:ext uri="{FF2B5EF4-FFF2-40B4-BE49-F238E27FC236}">
                  <a16:creationId xmlns="" xmlns:a16="http://schemas.microsoft.com/office/drawing/2014/main" id="{F1CA9EED-732A-5843-B9CA-4043B8309A21}"/>
                </a:ext>
              </a:extLst>
            </p:cNvPr>
            <p:cNvSpPr txBox="1"/>
            <p:nvPr/>
          </p:nvSpPr>
          <p:spPr>
            <a:xfrm>
              <a:off x="2327946" y="2447064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/>
                  <a:cs typeface="Arial"/>
                </a:rPr>
                <a:t>214 </a:t>
              </a:r>
              <a:r>
                <a:rPr lang="de-DE" sz="1000" b="1" dirty="0" err="1">
                  <a:latin typeface="Arial"/>
                  <a:cs typeface="Arial"/>
                </a:rPr>
                <a:t>bp</a:t>
              </a:r>
              <a:endParaRPr lang="de-DE" sz="10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00630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reitbild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-Desig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uido Piontek</dc:creator>
  <cp:lastModifiedBy>Markus Wirth</cp:lastModifiedBy>
  <cp:revision>14</cp:revision>
  <dcterms:created xsi:type="dcterms:W3CDTF">2017-12-08T17:36:21Z</dcterms:created>
  <dcterms:modified xsi:type="dcterms:W3CDTF">2018-02-24T14:42:13Z</dcterms:modified>
</cp:coreProperties>
</file>